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408C28-2633-4C10-B89C-48352205B14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D03BC0-3B07-4E33-A160-6FE5BD27BC0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5A1A01-01CA-420F-97E4-5F4CC85EA62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900EE3-DD60-45B4-9419-04A0C72737A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AE27CA-F1C3-494A-8EA6-19F90508D7B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1D44CF-BD58-47CC-AACD-A7DA2F0FBD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0E2E7A-A18E-434B-B6EB-8197581F84E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6AB5BC-0C97-4857-9A1E-29577250D7B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43776C-649B-418E-BDC2-F3C30374F1B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947578-763D-4891-9F52-487D80FCAAB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937C9A-9BCE-4173-929F-05CB3F7F858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24149D-B761-46B7-8764-6299C801B5B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2CC5072-5BEC-4E89-AC35-66E901D3FD46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image" Target="../media/image2.wmf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Object 250"/>
          <p:cNvGraphicFramePr/>
          <p:nvPr/>
        </p:nvGraphicFramePr>
        <p:xfrm>
          <a:off x="333360" y="250920"/>
          <a:ext cx="6257880" cy="375264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2" name="Object 250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33360" y="250920"/>
                    <a:ext cx="6257880" cy="3752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3" name="Text Box 495"/>
          <p:cNvSpPr/>
          <p:nvPr/>
        </p:nvSpPr>
        <p:spPr>
          <a:xfrm>
            <a:off x="189000" y="241200"/>
            <a:ext cx="718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496"/>
          <p:cNvSpPr/>
          <p:nvPr/>
        </p:nvSpPr>
        <p:spPr>
          <a:xfrm>
            <a:off x="262080" y="1393920"/>
            <a:ext cx="718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497"/>
          <p:cNvSpPr/>
          <p:nvPr/>
        </p:nvSpPr>
        <p:spPr>
          <a:xfrm>
            <a:off x="150840" y="2546280"/>
            <a:ext cx="719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0.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498"/>
          <p:cNvSpPr/>
          <p:nvPr/>
        </p:nvSpPr>
        <p:spPr>
          <a:xfrm>
            <a:off x="88920" y="3699000"/>
            <a:ext cx="719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0.0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499"/>
          <p:cNvSpPr/>
          <p:nvPr/>
        </p:nvSpPr>
        <p:spPr>
          <a:xfrm>
            <a:off x="0" y="1374840"/>
            <a:ext cx="431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" name="Picture 501" descr=""/>
          <p:cNvPicPr/>
          <p:nvPr/>
        </p:nvPicPr>
        <p:blipFill>
          <a:blip r:embed="rId3"/>
          <a:stretch/>
        </p:blipFill>
        <p:spPr>
          <a:xfrm>
            <a:off x="476280" y="3851280"/>
            <a:ext cx="5977080" cy="576360"/>
          </a:xfrm>
          <a:prstGeom prst="rect">
            <a:avLst/>
          </a:prstGeom>
          <a:ln w="0">
            <a:noFill/>
          </a:ln>
        </p:spPr>
      </p:pic>
      <p:sp>
        <p:nvSpPr>
          <p:cNvPr id="49" name="Text Box 502"/>
          <p:cNvSpPr/>
          <p:nvPr/>
        </p:nvSpPr>
        <p:spPr>
          <a:xfrm>
            <a:off x="333360" y="4067280"/>
            <a:ext cx="2872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alibri"/>
              </a:rPr>
              <a:t>R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503"/>
          <p:cNvSpPr/>
          <p:nvPr/>
        </p:nvSpPr>
        <p:spPr>
          <a:xfrm>
            <a:off x="285840" y="4249800"/>
            <a:ext cx="2872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alibri"/>
              </a:rPr>
              <a:t>LV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CasellaDiTesto 12"/>
          <p:cNvSpPr/>
          <p:nvPr/>
        </p:nvSpPr>
        <p:spPr>
          <a:xfrm>
            <a:off x="2637000" y="133200"/>
            <a:ext cx="20160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otal HCC cases N=39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CasellaDiTesto 11"/>
          <p:cNvSpPr/>
          <p:nvPr/>
        </p:nvSpPr>
        <p:spPr>
          <a:xfrm>
            <a:off x="333360" y="4788000"/>
            <a:ext cx="6191280" cy="954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Book Antiqua"/>
              </a:rPr>
              <a:t>miR-193a expression level detected by real-time PCR in tissues from biopsy specimens from patients affected by HCC. The graph indicates the R (RQ</a:t>
            </a:r>
            <a:r>
              <a:rPr b="0" lang="en-GB" sz="1100" spc="-1" strike="noStrike" baseline="-25000">
                <a:solidFill>
                  <a:srgbClr val="000000"/>
                </a:solidFill>
                <a:latin typeface="Book Antiqua"/>
              </a:rPr>
              <a:t>HCC</a:t>
            </a:r>
            <a:r>
              <a:rPr b="0" lang="en-GB" sz="1100" spc="-1" strike="noStrike">
                <a:solidFill>
                  <a:srgbClr val="000000"/>
                </a:solidFill>
                <a:latin typeface="Book Antiqua"/>
              </a:rPr>
              <a:t>/RQ</a:t>
            </a:r>
            <a:r>
              <a:rPr b="0" lang="en-GB" sz="1100" spc="-1" strike="noStrike" baseline="-25000">
                <a:solidFill>
                  <a:srgbClr val="000000"/>
                </a:solidFill>
                <a:latin typeface="Book Antiqua"/>
              </a:rPr>
              <a:t>PT</a:t>
            </a:r>
            <a:r>
              <a:rPr b="0" lang="en-GB" sz="1100" spc="-1" strike="noStrike">
                <a:solidFill>
                  <a:srgbClr val="000000"/>
                </a:solidFill>
                <a:latin typeface="Book Antiqua"/>
              </a:rPr>
              <a:t>) corresponding to the human sample tested. The histograms are ordinated by increasing R. The background disease are also indicated (LC, liver cirrhosis; O, other background disease i.e., B/C viral hepatitis, steatosis). The R values and the case number (LV) are listed under the graph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CasellaDiTesto 12"/>
          <p:cNvSpPr/>
          <p:nvPr/>
        </p:nvSpPr>
        <p:spPr>
          <a:xfrm>
            <a:off x="5157720" y="8686800"/>
            <a:ext cx="1943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Book Antiqua"/>
              </a:rPr>
              <a:t>Additional file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3-21T10:16:11Z</dcterms:created>
  <dc:creator>salvi</dc:creator>
  <dc:description/>
  <dc:language>en-US</dc:language>
  <cp:lastModifiedBy>De Petro</cp:lastModifiedBy>
  <dcterms:modified xsi:type="dcterms:W3CDTF">2013-07-05T15:41:22Z</dcterms:modified>
  <cp:revision>5</cp:revision>
  <dc:subject/>
  <dc:title>Diapositiva 1</dc:title>
</cp:coreProperties>
</file>